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8"/>
  </p:notesMasterIdLst>
  <p:sldIdLst>
    <p:sldId id="266" r:id="rId2"/>
    <p:sldId id="261" r:id="rId3"/>
    <p:sldId id="262" r:id="rId4"/>
    <p:sldId id="263" r:id="rId5"/>
    <p:sldId id="264" r:id="rId6"/>
    <p:sldId id="265" r:id="rId7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4" roundtripDataSignature="AMtx7mip9XlyYiD1LsoPc0M9KhHF94NNW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BA497380-E6CB-4EB0-AC02-B812CD3912A1}">
  <a:tblStyle styleId="{BA497380-E6CB-4EB0-AC02-B812CD3912A1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63" autoAdjust="0"/>
    <p:restoredTop sz="85053" autoAdjust="0"/>
  </p:normalViewPr>
  <p:slideViewPr>
    <p:cSldViewPr snapToGrid="0">
      <p:cViewPr>
        <p:scale>
          <a:sx n="70" d="100"/>
          <a:sy n="70" d="100"/>
        </p:scale>
        <p:origin x="-66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4" Type="http://schemas.openxmlformats.org/officeDocument/2006/relationships/slide" Target="slides/slide3.xml"/><Relationship Id="rId14" Type="http://customschemas.google.com/relationships/presentationmetadata" Target="metadata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36402752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7" name="Google Shape;127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800" b="0" dirty="0"/>
          </a:p>
        </p:txBody>
      </p:sp>
      <p:sp>
        <p:nvSpPr>
          <p:cNvPr id="128" name="Google Shape;128;p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g187efe90d78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8" name="Google Shape;138;g187efe90d78_0_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39" name="Google Shape;139;g187efe90d78_0_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3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ull gel image SKOV3 ACP treated and untreated gene expression (1)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/>
              <a:t>Red boxes represent the bands that have been cropped and added to Figure S3 (C)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EAC833-60BD-4CAD-849C-1AAC0AF725E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0353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ull gel image SKOV3 ACP treated and untreated gene expression (2)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/>
              <a:t>Red boxes represent the bands that have been cropped and added to Figure S3 (C)</a:t>
            </a:r>
            <a:endParaRPr lang="en-US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EAC833-60BD-4CAD-849C-1AAC0AF725E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8096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ull gel image SKOV3 ACP treated and untreated gene expression (3)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-RT Control : negative</a:t>
            </a:r>
            <a:r>
              <a:rPr lang="en-US" baseline="0" dirty="0"/>
              <a:t> reverse transcriptase control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/>
              <a:t>Red boxes represent the bands that have been cropped and added to Figure S3 (C)</a:t>
            </a:r>
            <a:endParaRPr lang="en-US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EAC833-60BD-4CAD-849C-1AAC0AF725E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1640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7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8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8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9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9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2" name="Google Shape;22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1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1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2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3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13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5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6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6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png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jpeg"/><Relationship Id="rId4" Type="http://schemas.openxmlformats.org/officeDocument/2006/relationships/image" Target="../media/image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jpeg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jpeg"/><Relationship Id="rId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219199" y="2197894"/>
            <a:ext cx="9965635" cy="30027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37-mer peptide treatment affected gene expression levels of certain EMT and Autophagy markers of SKOV3 cells. 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s were treated with peptide IC50 for 24 h and profiled for EMT and Autophagy markers. Gene expression data were generated and normalized agains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a control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, B-Cateni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entin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expression were significant in treated cells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-Cateni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creased, while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reased) compared to control.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Autophagy genes showed a significant increase of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5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6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cells, compared to untreated SKOV3s, while exposure to the peptide inhibited expression of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7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ed to untreated cells (“**” denotes P&lt;0.001, “****” denotes P&lt;0.00001, n=3).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gel images of SKOV3 genes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, Beta-catenin, Vimentin, ATG5, ATG6, ATG7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PDH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displayed.</a:t>
            </a:r>
          </a:p>
        </p:txBody>
      </p:sp>
    </p:spTree>
    <p:extLst>
      <p:ext uri="{BB962C8B-B14F-4D97-AF65-F5344CB8AC3E}">
        <p14:creationId xmlns:p14="http://schemas.microsoft.com/office/powerpoint/2010/main" val="7326808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</a:t>
            </a:fld>
            <a:endParaRPr/>
          </a:p>
        </p:txBody>
      </p:sp>
      <p:sp>
        <p:nvSpPr>
          <p:cNvPr id="131" name="Google Shape;131;p6"/>
          <p:cNvSpPr/>
          <p:nvPr/>
        </p:nvSpPr>
        <p:spPr>
          <a:xfrm>
            <a:off x="7067867" y="6094413"/>
            <a:ext cx="12192000" cy="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Calibri"/>
              <a:buNone/>
            </a:pPr>
            <a:r>
              <a:rPr lang="en-US" sz="1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2" name="Google Shape;132;p6"/>
          <p:cNvSpPr txBox="1"/>
          <p:nvPr/>
        </p:nvSpPr>
        <p:spPr>
          <a:xfrm>
            <a:off x="257729" y="713433"/>
            <a:ext cx="57037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A)</a:t>
            </a:r>
            <a:endParaRPr/>
          </a:p>
        </p:txBody>
      </p:sp>
      <p:sp>
        <p:nvSpPr>
          <p:cNvPr id="133" name="Google Shape;133;p6"/>
          <p:cNvSpPr txBox="1"/>
          <p:nvPr/>
        </p:nvSpPr>
        <p:spPr>
          <a:xfrm>
            <a:off x="6246139" y="713433"/>
            <a:ext cx="5955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B)</a:t>
            </a:r>
            <a:endParaRPr/>
          </a:p>
        </p:txBody>
      </p:sp>
      <p:graphicFrame>
        <p:nvGraphicFramePr>
          <p:cNvPr id="134" name="Google Shape;134;p6"/>
          <p:cNvGraphicFramePr/>
          <p:nvPr/>
        </p:nvGraphicFramePr>
        <p:xfrm>
          <a:off x="346075" y="1016000"/>
          <a:ext cx="5983288" cy="4937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r:id="rId4" imgW="5983288" imgH="4937125" progId="Prism7.Document">
                  <p:embed/>
                </p:oleObj>
              </mc:Choice>
              <mc:Fallback>
                <p:oleObj r:id="rId4" imgW="5983288" imgH="4937125" progId="Prism7.Document">
                  <p:embed/>
                  <p:pic>
                    <p:nvPicPr>
                      <p:cNvPr id="134" name="Google Shape;134;p6"/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/>
                      <a:stretch/>
                    </p:blipFill>
                    <p:spPr>
                      <a:xfrm>
                        <a:off x="346075" y="1016000"/>
                        <a:ext cx="5983288" cy="4937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5" name="Google Shape;135;p6"/>
          <p:cNvGraphicFramePr/>
          <p:nvPr/>
        </p:nvGraphicFramePr>
        <p:xfrm>
          <a:off x="6527800" y="928688"/>
          <a:ext cx="5499100" cy="4937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r:id="rId6" imgW="5499100" imgH="4937125" progId="Prism7.Document">
                  <p:embed/>
                </p:oleObj>
              </mc:Choice>
              <mc:Fallback>
                <p:oleObj r:id="rId6" imgW="5499100" imgH="4937125" progId="Prism7.Document">
                  <p:embed/>
                  <p:pic>
                    <p:nvPicPr>
                      <p:cNvPr id="135" name="Google Shape;135;p6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/>
                      <a:stretch/>
                    </p:blipFill>
                    <p:spPr>
                      <a:xfrm>
                        <a:off x="6527800" y="928688"/>
                        <a:ext cx="5499100" cy="4937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picture containing table&#10;&#10;Description automatically generated">
            <a:extLst>
              <a:ext uri="{FF2B5EF4-FFF2-40B4-BE49-F238E27FC236}">
                <a16:creationId xmlns:a16="http://schemas.microsoft.com/office/drawing/2014/main" xmlns="" id="{D5D31FF7-C834-D001-8591-6C5317F3A2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0265" y="753661"/>
            <a:ext cx="9729697" cy="5350677"/>
          </a:xfrm>
          <a:prstGeom prst="rect">
            <a:avLst/>
          </a:prstGeom>
        </p:spPr>
      </p:pic>
      <p:sp>
        <p:nvSpPr>
          <p:cNvPr id="142" name="Google Shape;142;g187efe90d78_0_0"/>
          <p:cNvSpPr txBox="1"/>
          <p:nvPr/>
        </p:nvSpPr>
        <p:spPr>
          <a:xfrm>
            <a:off x="3843354" y="1649624"/>
            <a:ext cx="5703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C)</a:t>
            </a:r>
            <a:endParaRPr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07D7CDEE-CB7E-44A6-95FC-D0226186E30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72" t="-27816" r="23989" b="27816"/>
          <a:stretch/>
        </p:blipFill>
        <p:spPr>
          <a:xfrm>
            <a:off x="2158282" y="1045065"/>
            <a:ext cx="5548265" cy="4829175"/>
          </a:xfrm>
          <a:prstGeom prst="rect">
            <a:avLst/>
          </a:prstGeom>
        </p:spPr>
      </p:pic>
      <p:pic>
        <p:nvPicPr>
          <p:cNvPr id="20" name="Picture 19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xmlns="" id="{203FE39A-3A1E-4C93-B335-B053BE04B3E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5" t="14295" r="90015" b="50904"/>
          <a:stretch/>
        </p:blipFill>
        <p:spPr>
          <a:xfrm>
            <a:off x="2407730" y="2929625"/>
            <a:ext cx="354031" cy="1793289"/>
          </a:xfrm>
          <a:prstGeom prst="rect">
            <a:avLst/>
          </a:prstGeom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xmlns="" id="{65606760-176C-4A3C-BE7A-3ABE3ED2E31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25" y="2124111"/>
            <a:ext cx="2209459" cy="43234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90252051-7065-4AF7-AEA4-F8D4BA72CE41}"/>
              </a:ext>
            </a:extLst>
          </p:cNvPr>
          <p:cNvSpPr txBox="1"/>
          <p:nvPr/>
        </p:nvSpPr>
        <p:spPr>
          <a:xfrm rot="17441312" flipH="1">
            <a:off x="2586980" y="1377346"/>
            <a:ext cx="20037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PDH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 rot="17565736">
            <a:off x="2895369" y="1339429"/>
            <a:ext cx="216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x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5C372E36-D864-44A4-8804-3131035AA59B}"/>
              </a:ext>
            </a:extLst>
          </p:cNvPr>
          <p:cNvSpPr txBox="1"/>
          <p:nvPr/>
        </p:nvSpPr>
        <p:spPr>
          <a:xfrm rot="17593168">
            <a:off x="3108496" y="1196042"/>
            <a:ext cx="2417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7114ACA7-8F63-4FB0-AD2B-F82E69DA5B90}"/>
              </a:ext>
            </a:extLst>
          </p:cNvPr>
          <p:cNvSpPr txBox="1"/>
          <p:nvPr/>
        </p:nvSpPr>
        <p:spPr>
          <a:xfrm rot="17472892">
            <a:off x="3378689" y="1192149"/>
            <a:ext cx="2481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F930318E-18D8-4B51-B9F5-F6632A19747B}"/>
              </a:ext>
            </a:extLst>
          </p:cNvPr>
          <p:cNvSpPr txBox="1"/>
          <p:nvPr/>
        </p:nvSpPr>
        <p:spPr>
          <a:xfrm rot="17542920">
            <a:off x="4325200" y="1217379"/>
            <a:ext cx="2326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288F18E2-343C-4A3C-98A4-7233319F4C4E}"/>
              </a:ext>
            </a:extLst>
          </p:cNvPr>
          <p:cNvSpPr txBox="1"/>
          <p:nvPr/>
        </p:nvSpPr>
        <p:spPr>
          <a:xfrm rot="17369373">
            <a:off x="4482175" y="1033430"/>
            <a:ext cx="26336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CC02D1C5-CE4A-4C6D-88CF-EF380164F4EA}"/>
              </a:ext>
            </a:extLst>
          </p:cNvPr>
          <p:cNvSpPr txBox="1"/>
          <p:nvPr/>
        </p:nvSpPr>
        <p:spPr>
          <a:xfrm rot="17329737">
            <a:off x="5053957" y="1463366"/>
            <a:ext cx="18067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14032B0F-F999-4705-8B40-78192D8A8AF2}"/>
              </a:ext>
            </a:extLst>
          </p:cNvPr>
          <p:cNvSpPr txBox="1"/>
          <p:nvPr/>
        </p:nvSpPr>
        <p:spPr>
          <a:xfrm rot="17324468">
            <a:off x="5155971" y="1192150"/>
            <a:ext cx="23874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7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7BC66675-2F87-432D-A1DE-7DB3D1AA2E51}"/>
              </a:ext>
            </a:extLst>
          </p:cNvPr>
          <p:cNvSpPr txBox="1"/>
          <p:nvPr/>
        </p:nvSpPr>
        <p:spPr>
          <a:xfrm rot="17406631">
            <a:off x="5560758" y="1252627"/>
            <a:ext cx="2295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79891298-1CAA-44F8-8988-630463CA1354}"/>
              </a:ext>
            </a:extLst>
          </p:cNvPr>
          <p:cNvSpPr txBox="1"/>
          <p:nvPr/>
        </p:nvSpPr>
        <p:spPr>
          <a:xfrm rot="17518212">
            <a:off x="5876813" y="1111997"/>
            <a:ext cx="2496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x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FBDD602D-BF74-4F89-9E31-B8C6D067FCCF}"/>
              </a:ext>
            </a:extLst>
          </p:cNvPr>
          <p:cNvSpPr txBox="1"/>
          <p:nvPr/>
        </p:nvSpPr>
        <p:spPr>
          <a:xfrm rot="17591784">
            <a:off x="6307290" y="1291335"/>
            <a:ext cx="2163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33C5A447-F11B-467A-9A70-E4F11B6A7ABF}"/>
              </a:ext>
            </a:extLst>
          </p:cNvPr>
          <p:cNvSpPr txBox="1"/>
          <p:nvPr/>
        </p:nvSpPr>
        <p:spPr>
          <a:xfrm rot="17424326">
            <a:off x="6517627" y="1179972"/>
            <a:ext cx="23778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6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99EDF256-F9CA-489A-9382-9DBAF44A69B9}"/>
              </a:ext>
            </a:extLst>
          </p:cNvPr>
          <p:cNvSpPr txBox="1"/>
          <p:nvPr/>
        </p:nvSpPr>
        <p:spPr>
          <a:xfrm rot="17262170">
            <a:off x="2282718" y="1469127"/>
            <a:ext cx="1699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kB Ladder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FF850D46-DB90-4F25-BBE1-3AA279EF079F}"/>
              </a:ext>
            </a:extLst>
          </p:cNvPr>
          <p:cNvSpPr txBox="1"/>
          <p:nvPr/>
        </p:nvSpPr>
        <p:spPr>
          <a:xfrm rot="17449599">
            <a:off x="3851387" y="1450939"/>
            <a:ext cx="1891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G7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618C96DA-CE11-49BA-B4E6-67DD37D601D2}"/>
              </a:ext>
            </a:extLst>
          </p:cNvPr>
          <p:cNvSpPr txBox="1"/>
          <p:nvPr/>
        </p:nvSpPr>
        <p:spPr>
          <a:xfrm rot="17517065">
            <a:off x="4067515" y="1307132"/>
            <a:ext cx="2128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PD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0ABFE852-B0A2-4910-B636-C721FB9CE606}"/>
              </a:ext>
            </a:extLst>
          </p:cNvPr>
          <p:cNvSpPr txBox="1"/>
          <p:nvPr/>
        </p:nvSpPr>
        <p:spPr>
          <a:xfrm rot="17565791">
            <a:off x="6575119" y="872110"/>
            <a:ext cx="30280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7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>
            <a:off x="3007147" y="1062428"/>
            <a:ext cx="18595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>
            <a:off x="4562535" y="1045064"/>
            <a:ext cx="18595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52" name="Straight Connector 51"/>
          <p:cNvCxnSpPr>
            <a:endCxn id="41" idx="0"/>
          </p:cNvCxnSpPr>
          <p:nvPr/>
        </p:nvCxnSpPr>
        <p:spPr>
          <a:xfrm>
            <a:off x="3230098" y="1517950"/>
            <a:ext cx="1452048" cy="1232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4897455" y="1531565"/>
            <a:ext cx="1300907" cy="1141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>
            <a:off x="6129363" y="1103028"/>
            <a:ext cx="18595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55" name="Straight Connector 54"/>
          <p:cNvCxnSpPr/>
          <p:nvPr/>
        </p:nvCxnSpPr>
        <p:spPr>
          <a:xfrm>
            <a:off x="6392341" y="1505622"/>
            <a:ext cx="1237552" cy="123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B2F95FD7-020A-31DE-8FEF-4255B5FCC933}"/>
              </a:ext>
            </a:extLst>
          </p:cNvPr>
          <p:cNvSpPr/>
          <p:nvPr/>
        </p:nvSpPr>
        <p:spPr>
          <a:xfrm>
            <a:off x="3014232" y="3886200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090C5F00-0B48-52A1-38FD-20E11A5FCD6E}"/>
              </a:ext>
            </a:extLst>
          </p:cNvPr>
          <p:cNvSpPr/>
          <p:nvPr/>
        </p:nvSpPr>
        <p:spPr>
          <a:xfrm>
            <a:off x="4538232" y="3890562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70205ECD-CEB7-6C68-0105-43438F25A4A3}"/>
              </a:ext>
            </a:extLst>
          </p:cNvPr>
          <p:cNvSpPr/>
          <p:nvPr/>
        </p:nvSpPr>
        <p:spPr>
          <a:xfrm>
            <a:off x="3657600" y="4165312"/>
            <a:ext cx="354031" cy="18457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93796B30-41DA-E9AE-224C-F446CF3E4821}"/>
              </a:ext>
            </a:extLst>
          </p:cNvPr>
          <p:cNvSpPr/>
          <p:nvPr/>
        </p:nvSpPr>
        <p:spPr>
          <a:xfrm>
            <a:off x="5243597" y="4158830"/>
            <a:ext cx="344403" cy="19105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8925A302-A5E0-4BDC-A81F-433F9CB642DF}"/>
              </a:ext>
            </a:extLst>
          </p:cNvPr>
          <p:cNvSpPr/>
          <p:nvPr/>
        </p:nvSpPr>
        <p:spPr>
          <a:xfrm>
            <a:off x="3962401" y="4150520"/>
            <a:ext cx="354031" cy="14236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73BD2E4B-4299-740C-6A94-10D28C732C3D}"/>
              </a:ext>
            </a:extLst>
          </p:cNvPr>
          <p:cNvSpPr/>
          <p:nvPr/>
        </p:nvSpPr>
        <p:spPr>
          <a:xfrm>
            <a:off x="5538770" y="4114801"/>
            <a:ext cx="354031" cy="19577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1589683A-FCB9-641D-09CD-62DDD6313180}"/>
              </a:ext>
            </a:extLst>
          </p:cNvPr>
          <p:cNvSpPr/>
          <p:nvPr/>
        </p:nvSpPr>
        <p:spPr>
          <a:xfrm>
            <a:off x="4267201" y="4089112"/>
            <a:ext cx="295335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9F088CFC-13BA-F1BD-9608-9D2DAE9F1C46}"/>
              </a:ext>
            </a:extLst>
          </p:cNvPr>
          <p:cNvSpPr/>
          <p:nvPr/>
        </p:nvSpPr>
        <p:spPr>
          <a:xfrm>
            <a:off x="5883173" y="4076148"/>
            <a:ext cx="354032" cy="19105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84556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90252051-7065-4AF7-AEA4-F8D4BA72CE41}"/>
              </a:ext>
            </a:extLst>
          </p:cNvPr>
          <p:cNvSpPr txBox="1"/>
          <p:nvPr/>
        </p:nvSpPr>
        <p:spPr>
          <a:xfrm rot="17441312" flipH="1">
            <a:off x="2524115" y="1377347"/>
            <a:ext cx="20037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 rot="17565736">
            <a:off x="2788590" y="1339429"/>
            <a:ext cx="216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ment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5C372E36-D864-44A4-8804-3131035AA59B}"/>
              </a:ext>
            </a:extLst>
          </p:cNvPr>
          <p:cNvSpPr txBox="1"/>
          <p:nvPr/>
        </p:nvSpPr>
        <p:spPr>
          <a:xfrm rot="17593168">
            <a:off x="3039397" y="1196042"/>
            <a:ext cx="2417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114ACA7-8F63-4FB0-AD2B-F82E69DA5B90}"/>
              </a:ext>
            </a:extLst>
          </p:cNvPr>
          <p:cNvSpPr txBox="1"/>
          <p:nvPr/>
        </p:nvSpPr>
        <p:spPr>
          <a:xfrm rot="17472892">
            <a:off x="3281346" y="1177161"/>
            <a:ext cx="2481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adher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F930318E-18D8-4B51-B9F5-F6632A19747B}"/>
              </a:ext>
            </a:extLst>
          </p:cNvPr>
          <p:cNvSpPr txBox="1"/>
          <p:nvPr/>
        </p:nvSpPr>
        <p:spPr>
          <a:xfrm rot="17542920">
            <a:off x="4236781" y="1256206"/>
            <a:ext cx="2326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288F18E2-343C-4A3C-98A4-7233319F4C4E}"/>
              </a:ext>
            </a:extLst>
          </p:cNvPr>
          <p:cNvSpPr txBox="1"/>
          <p:nvPr/>
        </p:nvSpPr>
        <p:spPr>
          <a:xfrm rot="17369373">
            <a:off x="4482119" y="1085437"/>
            <a:ext cx="26336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-Cadher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CC02D1C5-CE4A-4C6D-88CF-EF380164F4EA}"/>
              </a:ext>
            </a:extLst>
          </p:cNvPr>
          <p:cNvSpPr txBox="1"/>
          <p:nvPr/>
        </p:nvSpPr>
        <p:spPr>
          <a:xfrm rot="17329737">
            <a:off x="4926372" y="1346144"/>
            <a:ext cx="20584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PD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14032B0F-F999-4705-8B40-78192D8A8AF2}"/>
              </a:ext>
            </a:extLst>
          </p:cNvPr>
          <p:cNvSpPr txBox="1"/>
          <p:nvPr/>
        </p:nvSpPr>
        <p:spPr>
          <a:xfrm rot="17324468">
            <a:off x="5131333" y="1192149"/>
            <a:ext cx="23874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7BC66675-2F87-432D-A1DE-7DB3D1AA2E51}"/>
              </a:ext>
            </a:extLst>
          </p:cNvPr>
          <p:cNvSpPr txBox="1"/>
          <p:nvPr/>
        </p:nvSpPr>
        <p:spPr>
          <a:xfrm rot="17406631">
            <a:off x="5466460" y="1252628"/>
            <a:ext cx="2295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79891298-1CAA-44F8-8988-630463CA1354}"/>
              </a:ext>
            </a:extLst>
          </p:cNvPr>
          <p:cNvSpPr txBox="1"/>
          <p:nvPr/>
        </p:nvSpPr>
        <p:spPr>
          <a:xfrm rot="17518212">
            <a:off x="5721876" y="1174295"/>
            <a:ext cx="2496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-Cadher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99EDF256-F9CA-489A-9382-9DBAF44A69B9}"/>
              </a:ext>
            </a:extLst>
          </p:cNvPr>
          <p:cNvSpPr txBox="1"/>
          <p:nvPr/>
        </p:nvSpPr>
        <p:spPr>
          <a:xfrm rot="17262170">
            <a:off x="2229450" y="1469127"/>
            <a:ext cx="1699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kB Ladder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F850D46-DB90-4F25-BBE1-3AA279EF079F}"/>
              </a:ext>
            </a:extLst>
          </p:cNvPr>
          <p:cNvSpPr txBox="1"/>
          <p:nvPr/>
        </p:nvSpPr>
        <p:spPr>
          <a:xfrm rot="17449599">
            <a:off x="3733694" y="1438823"/>
            <a:ext cx="1891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18C96DA-CE11-49BA-B4E6-67DD37D601D2}"/>
              </a:ext>
            </a:extLst>
          </p:cNvPr>
          <p:cNvSpPr txBox="1"/>
          <p:nvPr/>
        </p:nvSpPr>
        <p:spPr>
          <a:xfrm rot="17517065">
            <a:off x="3981261" y="1333715"/>
            <a:ext cx="2128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mentin</a:t>
            </a:r>
          </a:p>
        </p:txBody>
      </p:sp>
      <p:pic>
        <p:nvPicPr>
          <p:cNvPr id="20" name="Picture 19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xmlns="" id="{203FE39A-3A1E-4C93-B335-B053BE04B3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r="38706" b="50904"/>
          <a:stretch/>
        </p:blipFill>
        <p:spPr>
          <a:xfrm>
            <a:off x="2341436" y="2436350"/>
            <a:ext cx="4483720" cy="2529905"/>
          </a:xfrm>
          <a:prstGeom prst="rect">
            <a:avLst/>
          </a:prstGeom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xmlns="" id="{65606760-176C-4A3C-BE7A-3ABE3ED2E31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26" y="2124112"/>
            <a:ext cx="1835101" cy="3590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>
            <a:off x="2941026" y="844473"/>
            <a:ext cx="18595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27" name="Straight Connector 26"/>
          <p:cNvCxnSpPr>
            <a:endCxn id="7" idx="0"/>
          </p:cNvCxnSpPr>
          <p:nvPr/>
        </p:nvCxnSpPr>
        <p:spPr>
          <a:xfrm>
            <a:off x="3217596" y="1248282"/>
            <a:ext cx="1189910" cy="74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>
            <a:off x="4248340" y="792759"/>
            <a:ext cx="18595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4580488" y="1244583"/>
            <a:ext cx="108643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B100F54E-E0CB-4DAD-8A92-4A762FA865E9}"/>
              </a:ext>
            </a:extLst>
          </p:cNvPr>
          <p:cNvSpPr txBox="1"/>
          <p:nvPr/>
        </p:nvSpPr>
        <p:spPr>
          <a:xfrm>
            <a:off x="5446000" y="791039"/>
            <a:ext cx="18595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5861782" y="1244583"/>
            <a:ext cx="102803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9E03CD36-B7A2-DF39-A719-3C784C00312E}"/>
              </a:ext>
            </a:extLst>
          </p:cNvPr>
          <p:cNvSpPr/>
          <p:nvPr/>
        </p:nvSpPr>
        <p:spPr>
          <a:xfrm>
            <a:off x="3304329" y="4619219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F7C6A5B1-1D54-507E-0590-97B075FB6109}"/>
              </a:ext>
            </a:extLst>
          </p:cNvPr>
          <p:cNvSpPr/>
          <p:nvPr/>
        </p:nvSpPr>
        <p:spPr>
          <a:xfrm>
            <a:off x="4522273" y="4669972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05476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 descr="A picture containing text, dark&#10;&#10;Description automatically generated">
            <a:extLst>
              <a:ext uri="{FF2B5EF4-FFF2-40B4-BE49-F238E27FC236}">
                <a16:creationId xmlns:a16="http://schemas.microsoft.com/office/drawing/2014/main" xmlns="" id="{881B9A26-596C-3143-FA95-DCEC2DCDFC0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8801" y="2124111"/>
            <a:ext cx="4976601" cy="3657636"/>
          </a:xfrm>
          <a:prstGeom prst="rect">
            <a:avLst/>
          </a:prstGeom>
        </p:spPr>
      </p:pic>
      <p:pic>
        <p:nvPicPr>
          <p:cNvPr id="3" name="Picture 2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xmlns="" id="{353D18A7-0D4C-7177-C056-E43BDF841C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65" r="12430"/>
          <a:stretch/>
        </p:blipFill>
        <p:spPr>
          <a:xfrm>
            <a:off x="2032000" y="2124111"/>
            <a:ext cx="4775200" cy="3657600"/>
          </a:xfrm>
          <a:prstGeom prst="rect">
            <a:avLst/>
          </a:prstGeom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xmlns="" id="{C55F3A53-C615-AE12-9AF7-F52A12409C6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26" y="2124112"/>
            <a:ext cx="1835101" cy="3590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80EEE68-FE17-6BC8-DF65-0701DC51F47A}"/>
              </a:ext>
            </a:extLst>
          </p:cNvPr>
          <p:cNvSpPr txBox="1"/>
          <p:nvPr/>
        </p:nvSpPr>
        <p:spPr>
          <a:xfrm rot="17441312" flipH="1">
            <a:off x="2236065" y="1105912"/>
            <a:ext cx="20037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+RT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B187FD9-71E7-9414-10B2-D59F64C06791}"/>
              </a:ext>
            </a:extLst>
          </p:cNvPr>
          <p:cNvSpPr txBox="1"/>
          <p:nvPr/>
        </p:nvSpPr>
        <p:spPr>
          <a:xfrm rot="17565736">
            <a:off x="2627708" y="1041110"/>
            <a:ext cx="216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-RT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B0F9A0A8-AB68-1C4B-E8C9-AF4AEBF3A6F3}"/>
              </a:ext>
            </a:extLst>
          </p:cNvPr>
          <p:cNvSpPr txBox="1"/>
          <p:nvPr/>
        </p:nvSpPr>
        <p:spPr>
          <a:xfrm rot="17593168">
            <a:off x="3047749" y="936847"/>
            <a:ext cx="2417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+RT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D373397F-1151-8A06-0A7B-FDA0CF07BA07}"/>
              </a:ext>
            </a:extLst>
          </p:cNvPr>
          <p:cNvSpPr txBox="1"/>
          <p:nvPr/>
        </p:nvSpPr>
        <p:spPr>
          <a:xfrm rot="17472892">
            <a:off x="3389370" y="885311"/>
            <a:ext cx="2481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-RT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CAE284F3-CAB6-A00D-0F3A-F51D94306FFF}"/>
              </a:ext>
            </a:extLst>
          </p:cNvPr>
          <p:cNvSpPr txBox="1"/>
          <p:nvPr/>
        </p:nvSpPr>
        <p:spPr>
          <a:xfrm rot="17542920">
            <a:off x="4698086" y="964015"/>
            <a:ext cx="2326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+RT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0A3580D1-DADE-8614-5668-8ECF2724C69D}"/>
              </a:ext>
            </a:extLst>
          </p:cNvPr>
          <p:cNvSpPr txBox="1"/>
          <p:nvPr/>
        </p:nvSpPr>
        <p:spPr>
          <a:xfrm rot="17369373">
            <a:off x="4939010" y="804251"/>
            <a:ext cx="26336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-RT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A3084E40-B06A-B709-5D16-8CD0DB9FC111}"/>
              </a:ext>
            </a:extLst>
          </p:cNvPr>
          <p:cNvSpPr txBox="1"/>
          <p:nvPr/>
        </p:nvSpPr>
        <p:spPr>
          <a:xfrm rot="17262170">
            <a:off x="1886476" y="1266747"/>
            <a:ext cx="1699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kB Ladd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5D212B85-364D-D0AC-B63D-267CB5AC0611}"/>
              </a:ext>
            </a:extLst>
          </p:cNvPr>
          <p:cNvSpPr txBox="1"/>
          <p:nvPr/>
        </p:nvSpPr>
        <p:spPr>
          <a:xfrm rot="17449599">
            <a:off x="3957253" y="1195404"/>
            <a:ext cx="1891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+RT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0622341D-DAA0-8D09-0986-3AD09F7B7E4D}"/>
              </a:ext>
            </a:extLst>
          </p:cNvPr>
          <p:cNvSpPr txBox="1"/>
          <p:nvPr/>
        </p:nvSpPr>
        <p:spPr>
          <a:xfrm rot="17517065">
            <a:off x="4266246" y="1071930"/>
            <a:ext cx="2128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(-RT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A1A1335D-C284-D6FD-0489-BA27AE632CAF}"/>
              </a:ext>
            </a:extLst>
          </p:cNvPr>
          <p:cNvSpPr txBox="1"/>
          <p:nvPr/>
        </p:nvSpPr>
        <p:spPr>
          <a:xfrm>
            <a:off x="2957532" y="1134283"/>
            <a:ext cx="7627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xmlns="" id="{0C509694-E9ED-1832-0F2A-62068EDC883B}"/>
              </a:ext>
            </a:extLst>
          </p:cNvPr>
          <p:cNvCxnSpPr>
            <a:cxnSpLocks/>
          </p:cNvCxnSpPr>
          <p:nvPr/>
        </p:nvCxnSpPr>
        <p:spPr>
          <a:xfrm>
            <a:off x="2965164" y="1482585"/>
            <a:ext cx="67943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F6AE3E69-77E3-D00D-BB3B-99969AE871A8}"/>
              </a:ext>
            </a:extLst>
          </p:cNvPr>
          <p:cNvSpPr txBox="1"/>
          <p:nvPr/>
        </p:nvSpPr>
        <p:spPr>
          <a:xfrm>
            <a:off x="3750921" y="1134283"/>
            <a:ext cx="9705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xmlns="" id="{2286A8E8-C64E-A4D7-68C9-412C445A4DD0}"/>
              </a:ext>
            </a:extLst>
          </p:cNvPr>
          <p:cNvCxnSpPr>
            <a:cxnSpLocks/>
          </p:cNvCxnSpPr>
          <p:nvPr/>
        </p:nvCxnSpPr>
        <p:spPr>
          <a:xfrm>
            <a:off x="3930442" y="1482585"/>
            <a:ext cx="6272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6C1DA506-496C-8D2B-8306-FB4F6CF9AFFB}"/>
              </a:ext>
            </a:extLst>
          </p:cNvPr>
          <p:cNvSpPr txBox="1"/>
          <p:nvPr/>
        </p:nvSpPr>
        <p:spPr>
          <a:xfrm rot="17441312" flipH="1">
            <a:off x="7415004" y="1125364"/>
            <a:ext cx="20037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RT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846065DF-4902-25BB-FF68-B846602100B3}"/>
              </a:ext>
            </a:extLst>
          </p:cNvPr>
          <p:cNvSpPr txBox="1"/>
          <p:nvPr/>
        </p:nvSpPr>
        <p:spPr>
          <a:xfrm rot="17565736">
            <a:off x="7755430" y="1047162"/>
            <a:ext cx="216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-RT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69244518-1A0F-8FCD-25D1-65AF2BEFA33A}"/>
              </a:ext>
            </a:extLst>
          </p:cNvPr>
          <p:cNvSpPr txBox="1"/>
          <p:nvPr/>
        </p:nvSpPr>
        <p:spPr>
          <a:xfrm rot="17593168">
            <a:off x="8111817" y="942899"/>
            <a:ext cx="2417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RT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6807475E-4481-AE60-A92A-633F3A9260B9}"/>
              </a:ext>
            </a:extLst>
          </p:cNvPr>
          <p:cNvSpPr txBox="1"/>
          <p:nvPr/>
        </p:nvSpPr>
        <p:spPr>
          <a:xfrm rot="17472892">
            <a:off x="8449421" y="867318"/>
            <a:ext cx="2481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-RT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904F33B1-1427-EA8A-6D3F-734DC8DA1B1C}"/>
              </a:ext>
            </a:extLst>
          </p:cNvPr>
          <p:cNvSpPr txBox="1"/>
          <p:nvPr/>
        </p:nvSpPr>
        <p:spPr>
          <a:xfrm rot="17542920">
            <a:off x="9739026" y="970067"/>
            <a:ext cx="2326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RT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3156B288-9134-F4C3-FA11-36B3BC1D4691}"/>
              </a:ext>
            </a:extLst>
          </p:cNvPr>
          <p:cNvSpPr txBox="1"/>
          <p:nvPr/>
        </p:nvSpPr>
        <p:spPr>
          <a:xfrm rot="17369373">
            <a:off x="9943012" y="810304"/>
            <a:ext cx="26336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-RT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5FE8B6D4-90A1-EF7B-259D-480754C3EA5B}"/>
              </a:ext>
            </a:extLst>
          </p:cNvPr>
          <p:cNvSpPr txBox="1"/>
          <p:nvPr/>
        </p:nvSpPr>
        <p:spPr>
          <a:xfrm rot="17262170">
            <a:off x="7082458" y="1272799"/>
            <a:ext cx="1699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kB Ladde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1CDAA71E-EA0D-79D6-BD53-8950EBE41F60}"/>
              </a:ext>
            </a:extLst>
          </p:cNvPr>
          <p:cNvSpPr txBox="1"/>
          <p:nvPr/>
        </p:nvSpPr>
        <p:spPr>
          <a:xfrm rot="17449599">
            <a:off x="9032631" y="1185688"/>
            <a:ext cx="1891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RT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62CCEE9A-C113-1C51-2DF4-D406F9BF6375}"/>
              </a:ext>
            </a:extLst>
          </p:cNvPr>
          <p:cNvSpPr txBox="1"/>
          <p:nvPr/>
        </p:nvSpPr>
        <p:spPr>
          <a:xfrm rot="17517065">
            <a:off x="9330584" y="1077982"/>
            <a:ext cx="2128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-RT)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xmlns="" id="{08507EDB-FE24-8EE7-5027-03C246396C4D}"/>
              </a:ext>
            </a:extLst>
          </p:cNvPr>
          <p:cNvSpPr/>
          <p:nvPr/>
        </p:nvSpPr>
        <p:spPr>
          <a:xfrm>
            <a:off x="2709432" y="3098512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6BC01723-8316-65C6-A247-7B8B917317B3}"/>
              </a:ext>
            </a:extLst>
          </p:cNvPr>
          <p:cNvSpPr/>
          <p:nvPr/>
        </p:nvSpPr>
        <p:spPr>
          <a:xfrm>
            <a:off x="3520270" y="3098512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0D62EE12-A0CF-228C-9A9A-088A85E288D4}"/>
              </a:ext>
            </a:extLst>
          </p:cNvPr>
          <p:cNvSpPr/>
          <p:nvPr/>
        </p:nvSpPr>
        <p:spPr>
          <a:xfrm>
            <a:off x="7789432" y="3479512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D1C4F6A7-25F3-1F1C-F201-DE140E9CCBC5}"/>
              </a:ext>
            </a:extLst>
          </p:cNvPr>
          <p:cNvSpPr/>
          <p:nvPr/>
        </p:nvSpPr>
        <p:spPr>
          <a:xfrm>
            <a:off x="8582213" y="3479512"/>
            <a:ext cx="440169" cy="1780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6892D1B3-94E7-4607-FA9B-568B4C307DED}"/>
              </a:ext>
            </a:extLst>
          </p:cNvPr>
          <p:cNvSpPr txBox="1"/>
          <p:nvPr/>
        </p:nvSpPr>
        <p:spPr>
          <a:xfrm>
            <a:off x="4721474" y="1127374"/>
            <a:ext cx="7011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xmlns="" id="{DBA0F082-8DD7-1AAA-2200-0685AA6FBD13}"/>
              </a:ext>
            </a:extLst>
          </p:cNvPr>
          <p:cNvCxnSpPr>
            <a:cxnSpLocks/>
          </p:cNvCxnSpPr>
          <p:nvPr/>
        </p:nvCxnSpPr>
        <p:spPr>
          <a:xfrm>
            <a:off x="4727434" y="1475676"/>
            <a:ext cx="67943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F6B1D846-AE9E-5AEB-6C98-1EA9DD270697}"/>
              </a:ext>
            </a:extLst>
          </p:cNvPr>
          <p:cNvSpPr txBox="1"/>
          <p:nvPr/>
        </p:nvSpPr>
        <p:spPr>
          <a:xfrm>
            <a:off x="5437551" y="1110339"/>
            <a:ext cx="9705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xmlns="" id="{76EE6538-1DB2-984B-14EB-6B124D71C890}"/>
              </a:ext>
            </a:extLst>
          </p:cNvPr>
          <p:cNvCxnSpPr>
            <a:cxnSpLocks/>
          </p:cNvCxnSpPr>
          <p:nvPr/>
        </p:nvCxnSpPr>
        <p:spPr>
          <a:xfrm>
            <a:off x="5617072" y="1458641"/>
            <a:ext cx="6272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58511E54-A65B-18AE-2567-42722688895F}"/>
              </a:ext>
            </a:extLst>
          </p:cNvPr>
          <p:cNvSpPr txBox="1"/>
          <p:nvPr/>
        </p:nvSpPr>
        <p:spPr>
          <a:xfrm>
            <a:off x="8236777" y="934228"/>
            <a:ext cx="7627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xmlns="" id="{291DA47D-6FD6-6D74-4F52-1AD0DE8CD636}"/>
              </a:ext>
            </a:extLst>
          </p:cNvPr>
          <p:cNvCxnSpPr>
            <a:cxnSpLocks/>
          </p:cNvCxnSpPr>
          <p:nvPr/>
        </p:nvCxnSpPr>
        <p:spPr>
          <a:xfrm>
            <a:off x="8244409" y="1282530"/>
            <a:ext cx="67943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08069EAF-4C73-F799-81C6-FC6FB4D26FF6}"/>
              </a:ext>
            </a:extLst>
          </p:cNvPr>
          <p:cNvSpPr txBox="1"/>
          <p:nvPr/>
        </p:nvSpPr>
        <p:spPr>
          <a:xfrm>
            <a:off x="8933187" y="934228"/>
            <a:ext cx="9705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xmlns="" id="{6A7DC41A-E3C8-ED5C-5B81-68E0D3D203E7}"/>
              </a:ext>
            </a:extLst>
          </p:cNvPr>
          <p:cNvCxnSpPr>
            <a:cxnSpLocks/>
          </p:cNvCxnSpPr>
          <p:nvPr/>
        </p:nvCxnSpPr>
        <p:spPr>
          <a:xfrm>
            <a:off x="9112708" y="1282530"/>
            <a:ext cx="6272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F577EB1C-2805-1C67-E77A-85756EF14231}"/>
              </a:ext>
            </a:extLst>
          </p:cNvPr>
          <p:cNvSpPr txBox="1"/>
          <p:nvPr/>
        </p:nvSpPr>
        <p:spPr>
          <a:xfrm>
            <a:off x="9882957" y="927319"/>
            <a:ext cx="7011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xmlns="" id="{24388062-DAA4-6020-75EF-4C53881F287E}"/>
              </a:ext>
            </a:extLst>
          </p:cNvPr>
          <p:cNvCxnSpPr>
            <a:cxnSpLocks/>
          </p:cNvCxnSpPr>
          <p:nvPr/>
        </p:nvCxnSpPr>
        <p:spPr>
          <a:xfrm>
            <a:off x="9888917" y="1275621"/>
            <a:ext cx="67943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D17B8CFF-65AC-E8FD-99A7-1CB38FE6680E}"/>
              </a:ext>
            </a:extLst>
          </p:cNvPr>
          <p:cNvSpPr txBox="1"/>
          <p:nvPr/>
        </p:nvSpPr>
        <p:spPr>
          <a:xfrm>
            <a:off x="10550543" y="910284"/>
            <a:ext cx="9705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</a:p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OV3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xmlns="" id="{468EC2D4-BED6-EAA0-9762-99F056BB16F9}"/>
              </a:ext>
            </a:extLst>
          </p:cNvPr>
          <p:cNvCxnSpPr>
            <a:cxnSpLocks/>
          </p:cNvCxnSpPr>
          <p:nvPr/>
        </p:nvCxnSpPr>
        <p:spPr>
          <a:xfrm>
            <a:off x="10730064" y="1258586"/>
            <a:ext cx="6272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8306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4</TotalTime>
  <Words>411</Words>
  <Application>Microsoft Office PowerPoint</Application>
  <PresentationFormat>Custom</PresentationFormat>
  <Paragraphs>93</Paragraphs>
  <Slides>6</Slides>
  <Notes>5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GraphPad Prism 7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led AbdelRaouf</dc:creator>
  <cp:lastModifiedBy>Sheri</cp:lastModifiedBy>
  <cp:revision>16</cp:revision>
  <dcterms:created xsi:type="dcterms:W3CDTF">2021-09-29T15:36:37Z</dcterms:created>
  <dcterms:modified xsi:type="dcterms:W3CDTF">2023-03-31T19:41:58Z</dcterms:modified>
</cp:coreProperties>
</file>